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docx" ContentType="application/vnd.openxmlformats-officedocument.wordprocessingml.documen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69785-3186-4D55-B903-BA4DC4332E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01900-F757-4408-9964-D18EEC6F36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D12D1-455F-42C2-AC6A-5DA315F104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947325-DF4B-4D59-8C9F-C4EBD645D3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A2567-9CFA-4C64-B7C4-64476A2813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03752-3E8A-4C86-B8F0-20850A0DE5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B59AA7-5B81-4B9E-B727-349C16E496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04038-B199-46A3-AA8E-75EB9F0E08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A12AE-1A32-4A92-9E45-1B7430C253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39D6A-06BF-4230-86C6-CADB76CB3D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15C21D-1FC7-4AF3-8B8D-B5273E12EF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673D7E-B601-4E82-8ADE-5DB546298E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ru-RU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92D815-9AEC-427B-8F89-FBF1D5D7E12F}" type="slidenum">
              <a:rPr b="0" lang="ru-RU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9.wmf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0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1116000" y="549360"/>
            <a:ext cx="7272360" cy="468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S</a:t>
            </a:r>
            <a:r>
              <a:rPr b="1" lang="ru-RU" sz="2400" spc="-1" strike="noStrike">
                <a:solidFill>
                  <a:srgbClr val="000000"/>
                </a:solidFill>
                <a:latin typeface="Times New Roman"/>
              </a:rPr>
              <a:t>2</a:t>
            </a: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 Table. Alignment of mtDNA HVR I sequences.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The name of each cloned sequence consist of: HVR I fragment (according to names of primers used for PCR)_Clone number.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equences ending with the word “dir” represent consensus sequence obtained by direct sequencing </a:t>
            </a:r>
            <a:r>
              <a:rPr b="0" lang="ru-RU" sz="2400" spc="-1" strike="noStrike">
                <a:solidFill>
                  <a:srgbClr val="000000"/>
                </a:solidFill>
                <a:latin typeface="Times New Roman"/>
              </a:rPr>
              <a:t>of amplicons obtained from different extracts (2-4 extracts for each sample) and repeated PCR of each extract (2 PCRs).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rCRS indicate the revised Cambridge Reference Sequence.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Object 4"/>
          <p:cNvGraphicFramePr/>
          <p:nvPr/>
        </p:nvGraphicFramePr>
        <p:xfrm>
          <a:off x="179280" y="1176480"/>
          <a:ext cx="8713800" cy="441324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65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9280" y="1176480"/>
                    <a:ext cx="8713800" cy="4413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6" name="Text Box 6"/>
          <p:cNvSpPr/>
          <p:nvPr/>
        </p:nvSpPr>
        <p:spPr>
          <a:xfrm>
            <a:off x="737640" y="209520"/>
            <a:ext cx="907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TA17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7" name="Object 4"/>
          <p:cNvGraphicFramePr/>
          <p:nvPr/>
        </p:nvGraphicFramePr>
        <p:xfrm>
          <a:off x="250920" y="977760"/>
          <a:ext cx="8642160" cy="583596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68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977760"/>
                    <a:ext cx="8642160" cy="5835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9" name="Text Box 6"/>
          <p:cNvSpPr/>
          <p:nvPr/>
        </p:nvSpPr>
        <p:spPr>
          <a:xfrm>
            <a:off x="665280" y="136440"/>
            <a:ext cx="723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Sts6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0" name="Object 4"/>
          <p:cNvGraphicFramePr/>
          <p:nvPr/>
        </p:nvGraphicFramePr>
        <p:xfrm>
          <a:off x="250920" y="855720"/>
          <a:ext cx="7850160" cy="587052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71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855720"/>
                    <a:ext cx="7850160" cy="5870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2" name="Text Box 6"/>
          <p:cNvSpPr/>
          <p:nvPr/>
        </p:nvSpPr>
        <p:spPr>
          <a:xfrm>
            <a:off x="881280" y="209520"/>
            <a:ext cx="875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Sts1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"/>
          <p:cNvGraphicFramePr/>
          <p:nvPr/>
        </p:nvGraphicFramePr>
        <p:xfrm>
          <a:off x="685800" y="609480"/>
          <a:ext cx="7772400" cy="5803920"/>
        </p:xfrm>
        <a:graphic>
          <a:graphicData uri="http://schemas.openxmlformats.org/drawingml/2006/table">
            <a:tbl>
              <a:tblPr/>
              <a:tblGrid>
                <a:gridCol w="1554120"/>
                <a:gridCol w="1554120"/>
                <a:gridCol w="1555920"/>
                <a:gridCol w="1554120"/>
                <a:gridCol w="1554120"/>
              </a:tblGrid>
              <a:tr h="35064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Sampl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15996-H161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16117-H162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17209-H1634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16287-H164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839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Ut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82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Ut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82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rz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O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Od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824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Krb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8212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TK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824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TA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8356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Sts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900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Sts1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marL="343080" indent="-343080"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SimSun"/>
                        </a:rPr>
                        <a:t>direct sequencing + clo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Object 8"/>
          <p:cNvGraphicFramePr/>
          <p:nvPr/>
        </p:nvGraphicFramePr>
        <p:xfrm>
          <a:off x="250920" y="836640"/>
          <a:ext cx="8713800" cy="535932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44" name="Object 8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836640"/>
                    <a:ext cx="8713800" cy="5359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10"/>
          <p:cNvSpPr/>
          <p:nvPr/>
        </p:nvSpPr>
        <p:spPr>
          <a:xfrm>
            <a:off x="378000" y="281160"/>
            <a:ext cx="65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Ut5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Object 5"/>
          <p:cNvGraphicFramePr/>
          <p:nvPr/>
        </p:nvGraphicFramePr>
        <p:xfrm>
          <a:off x="179280" y="1052640"/>
          <a:ext cx="8785440" cy="540216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47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9280" y="1052640"/>
                    <a:ext cx="8785440" cy="5402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8" name="Text Box 6"/>
          <p:cNvSpPr/>
          <p:nvPr/>
        </p:nvSpPr>
        <p:spPr>
          <a:xfrm>
            <a:off x="449640" y="209520"/>
            <a:ext cx="807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Ut38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" name="Object 4"/>
          <p:cNvGraphicFramePr/>
          <p:nvPr/>
        </p:nvGraphicFramePr>
        <p:xfrm>
          <a:off x="179280" y="1498680"/>
          <a:ext cx="8785440" cy="370836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50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9280" y="1498680"/>
                    <a:ext cx="8785440" cy="3708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1" name="Text Box 6"/>
          <p:cNvSpPr/>
          <p:nvPr/>
        </p:nvSpPr>
        <p:spPr>
          <a:xfrm>
            <a:off x="448200" y="352440"/>
            <a:ext cx="842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Krz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2" name="Object 4"/>
          <p:cNvGraphicFramePr/>
          <p:nvPr/>
        </p:nvGraphicFramePr>
        <p:xfrm>
          <a:off x="324000" y="684360"/>
          <a:ext cx="8569080" cy="620064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5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24000" y="684360"/>
                    <a:ext cx="8569080" cy="6200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4" name="Text Box 6"/>
          <p:cNvSpPr/>
          <p:nvPr/>
        </p:nvSpPr>
        <p:spPr>
          <a:xfrm>
            <a:off x="593640" y="136440"/>
            <a:ext cx="740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Od7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5" name="Object 4"/>
          <p:cNvGraphicFramePr/>
          <p:nvPr/>
        </p:nvGraphicFramePr>
        <p:xfrm>
          <a:off x="250920" y="1177920"/>
          <a:ext cx="8642160" cy="541980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56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1177920"/>
                    <a:ext cx="8642160" cy="5419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7" name="Text Box 6"/>
          <p:cNvSpPr/>
          <p:nvPr/>
        </p:nvSpPr>
        <p:spPr>
          <a:xfrm>
            <a:off x="449280" y="281160"/>
            <a:ext cx="892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Od1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Object 4"/>
          <p:cNvGraphicFramePr/>
          <p:nvPr/>
        </p:nvGraphicFramePr>
        <p:xfrm>
          <a:off x="250920" y="1371600"/>
          <a:ext cx="8713800" cy="399420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59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1371600"/>
                    <a:ext cx="8713800" cy="3994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Text Box 6"/>
          <p:cNvSpPr/>
          <p:nvPr/>
        </p:nvSpPr>
        <p:spPr>
          <a:xfrm>
            <a:off x="880560" y="281160"/>
            <a:ext cx="1028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Krb10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" name="Object 4"/>
          <p:cNvGraphicFramePr/>
          <p:nvPr/>
        </p:nvGraphicFramePr>
        <p:xfrm>
          <a:off x="314280" y="1092240"/>
          <a:ext cx="8650440" cy="521640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62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14280" y="1092240"/>
                    <a:ext cx="8650440" cy="5216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3" name="Text Box 6"/>
          <p:cNvSpPr/>
          <p:nvPr/>
        </p:nvSpPr>
        <p:spPr>
          <a:xfrm>
            <a:off x="520560" y="352440"/>
            <a:ext cx="925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TK10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08T19:28:31Z</dcterms:created>
  <dc:creator>а</dc:creator>
  <dc:description/>
  <dc:language>en-US</dc:language>
  <cp:lastModifiedBy>Александр Пилипенко</cp:lastModifiedBy>
  <dcterms:modified xsi:type="dcterms:W3CDTF">2015-04-18T19:27:54Z</dcterms:modified>
  <cp:revision>19</cp:revision>
  <dc:subject/>
  <dc:title>PowerPoint Presentation</dc:title>
</cp:coreProperties>
</file>